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3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735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054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291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041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673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58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406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433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45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986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792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04B55-60DD-48EF-9B60-E4046FC37C57}" type="datetimeFigureOut">
              <a:rPr lang="en-US" smtClean="0"/>
              <a:t>2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ADD26-759F-45CB-B7E3-B904C757E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752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6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11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openxmlformats.org/officeDocument/2006/relationships/image" Target="../media/image27.tiff"/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12" Type="http://schemas.openxmlformats.org/officeDocument/2006/relationships/image" Target="../media/image26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0.tiff"/><Relationship Id="rId11" Type="http://schemas.openxmlformats.org/officeDocument/2006/relationships/image" Target="../media/image25.tiff"/><Relationship Id="rId5" Type="http://schemas.openxmlformats.org/officeDocument/2006/relationships/image" Target="../media/image19.tiff"/><Relationship Id="rId10" Type="http://schemas.openxmlformats.org/officeDocument/2006/relationships/image" Target="../media/image24.tiff"/><Relationship Id="rId4" Type="http://schemas.openxmlformats.org/officeDocument/2006/relationships/image" Target="../media/image18.tiff"/><Relationship Id="rId9" Type="http://schemas.openxmlformats.org/officeDocument/2006/relationships/image" Target="../media/image2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A63E5EC-6BBA-4D60-A1D2-472027AF02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1004" y="990601"/>
            <a:ext cx="6852107" cy="380787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3C4748D-381E-44BF-9805-ED75212E10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993" y="2007446"/>
            <a:ext cx="4474578" cy="2430106"/>
          </a:xfrm>
          <a:prstGeom prst="rect">
            <a:avLst/>
          </a:prstGeom>
        </p:spPr>
      </p:pic>
      <p:sp>
        <p:nvSpPr>
          <p:cNvPr id="5" name="Title 1">
            <a:extLst>
              <a:ext uri="{FF2B5EF4-FFF2-40B4-BE49-F238E27FC236}">
                <a16:creationId xmlns:a16="http://schemas.microsoft.com/office/drawing/2014/main" id="{D599C9E7-5897-4137-815C-851C813BD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7463" y="99897"/>
            <a:ext cx="11040000" cy="672000"/>
          </a:xfrm>
        </p:spPr>
        <p:txBody>
          <a:bodyPr>
            <a:normAutofit/>
          </a:bodyPr>
          <a:lstStyle/>
          <a:p>
            <a:r>
              <a:rPr lang="en-GB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GB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ay setup and gating strateg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133CF0-8C05-4565-9116-0A7B0F94C89F}"/>
              </a:ext>
            </a:extLst>
          </p:cNvPr>
          <p:cNvSpPr txBox="1"/>
          <p:nvPr/>
        </p:nvSpPr>
        <p:spPr>
          <a:xfrm>
            <a:off x="190837" y="1205012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  <a:endParaRPr lang="en-GB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DD2B1DE-314B-4951-9D6A-803513F96FD8}"/>
              </a:ext>
            </a:extLst>
          </p:cNvPr>
          <p:cNvSpPr txBox="1"/>
          <p:nvPr/>
        </p:nvSpPr>
        <p:spPr>
          <a:xfrm>
            <a:off x="5201004" y="120499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577325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93ACAEE0-AF88-4F0B-9932-AEFDED7DC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9868" y="32300"/>
            <a:ext cx="11040000" cy="672000"/>
          </a:xfrm>
        </p:spPr>
        <p:txBody>
          <a:bodyPr>
            <a:normAutofit/>
          </a:bodyPr>
          <a:lstStyle/>
          <a:p>
            <a:r>
              <a:rPr lang="en-GB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acterisation of </a:t>
            </a:r>
            <a:r>
              <a:rPr lang="en-GB"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TICS</a:t>
            </a:r>
            <a:endParaRPr lang="en-GB" sz="2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796D3B4-71BC-4AC2-9AE8-6F7FC55696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3005705"/>
              </p:ext>
            </p:extLst>
          </p:nvPr>
        </p:nvGraphicFramePr>
        <p:xfrm>
          <a:off x="6606574" y="3459822"/>
          <a:ext cx="2342906" cy="24033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7" r:id="rId3" imgW="2826705" imgH="2899960" progId="Prism7.Document">
                  <p:embed/>
                </p:oleObj>
              </mc:Choice>
              <mc:Fallback>
                <p:oleObj name="Prism 7" r:id="rId3" imgW="2826705" imgH="2899960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796D3B4-71BC-4AC2-9AE8-6F7FC55696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06574" y="3459822"/>
                        <a:ext cx="2342906" cy="24033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CE5598D-66EA-474C-A299-B419B81BE7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7576292"/>
              </p:ext>
            </p:extLst>
          </p:nvPr>
        </p:nvGraphicFramePr>
        <p:xfrm>
          <a:off x="9011618" y="3459822"/>
          <a:ext cx="2403391" cy="24033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7" r:id="rId5" imgW="2899813" imgH="2899960" progId="Prism7.Document">
                  <p:embed/>
                </p:oleObj>
              </mc:Choice>
              <mc:Fallback>
                <p:oleObj name="Prism 7" r:id="rId5" imgW="2899813" imgH="2899960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CE5598D-66EA-474C-A299-B419B81BE7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011618" y="3459822"/>
                        <a:ext cx="2403391" cy="24033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C1D447DB-2E3D-455F-B4F7-9DD8C1405791}"/>
              </a:ext>
            </a:extLst>
          </p:cNvPr>
          <p:cNvSpPr txBox="1"/>
          <p:nvPr/>
        </p:nvSpPr>
        <p:spPr>
          <a:xfrm>
            <a:off x="159868" y="58723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3689E79-925D-4944-BE3E-7BABAC2FF7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8151720"/>
              </p:ext>
            </p:extLst>
          </p:nvPr>
        </p:nvGraphicFramePr>
        <p:xfrm>
          <a:off x="316321" y="642897"/>
          <a:ext cx="1944501" cy="20300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6" r:id="rId7" imgW="3082762" imgH="3220137" progId="Prism6.Document">
                  <p:embed/>
                </p:oleObj>
              </mc:Choice>
              <mc:Fallback>
                <p:oleObj name="Prism 6" r:id="rId7" imgW="3082762" imgH="3220137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3689E79-925D-4944-BE3E-7BABAC2FF7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6321" y="642897"/>
                        <a:ext cx="1944501" cy="20300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CFDBE67-3519-400F-9C2B-FA9B91E034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943247"/>
              </p:ext>
            </p:extLst>
          </p:nvPr>
        </p:nvGraphicFramePr>
        <p:xfrm>
          <a:off x="2135258" y="642896"/>
          <a:ext cx="1941827" cy="2030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6" r:id="rId9" imgW="3078080" imgH="3220137" progId="Prism6.Document">
                  <p:embed/>
                </p:oleObj>
              </mc:Choice>
              <mc:Fallback>
                <p:oleObj name="Prism 6" r:id="rId9" imgW="3078080" imgH="3220137" progId="Prism6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CFDBE67-3519-400F-9C2B-FA9B91E034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35258" y="642896"/>
                        <a:ext cx="1941827" cy="2030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6954FE3D-097D-483D-A352-EDDC621141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4678109"/>
              </p:ext>
            </p:extLst>
          </p:nvPr>
        </p:nvGraphicFramePr>
        <p:xfrm>
          <a:off x="3840191" y="670255"/>
          <a:ext cx="1941827" cy="2036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6" r:id="rId11" imgW="3078080" imgH="3229141" progId="Prism6.Document">
                  <p:embed/>
                </p:oleObj>
              </mc:Choice>
              <mc:Fallback>
                <p:oleObj name="Prism 6" r:id="rId11" imgW="3078080" imgH="3229141" progId="Prism6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6954FE3D-097D-483D-A352-EDDC621141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40191" y="670255"/>
                        <a:ext cx="1941827" cy="2036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943CEF0D-67B4-4C27-8E45-C94B842EE1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1070313"/>
              </p:ext>
            </p:extLst>
          </p:nvPr>
        </p:nvGraphicFramePr>
        <p:xfrm>
          <a:off x="5554131" y="572017"/>
          <a:ext cx="2936812" cy="2171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Prism 8" r:id="rId13" imgW="4363404" imgH="3229141" progId="Prism8.Document">
                  <p:embed/>
                </p:oleObj>
              </mc:Choice>
              <mc:Fallback>
                <p:oleObj name="Prism 8" r:id="rId13" imgW="4363404" imgH="3229141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943CEF0D-67B4-4C27-8E45-C94B842EE1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554131" y="572017"/>
                        <a:ext cx="2936812" cy="2171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BC45452F-3B66-4EE7-87B4-557964F3D5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239684"/>
              </p:ext>
            </p:extLst>
          </p:nvPr>
        </p:nvGraphicFramePr>
        <p:xfrm>
          <a:off x="9196551" y="642896"/>
          <a:ext cx="1818383" cy="24233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7" r:id="rId15" imgW="2221317" imgH="2960826" progId="Prism7.Document">
                  <p:embed/>
                </p:oleObj>
              </mc:Choice>
              <mc:Fallback>
                <p:oleObj name="Prism 7" r:id="rId15" imgW="2221317" imgH="2960826" progId="Prism7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BC45452F-3B66-4EE7-87B4-557964F3D5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196551" y="642896"/>
                        <a:ext cx="1818383" cy="24233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201B38DC-B17D-499E-8747-27C7936B21BB}"/>
              </a:ext>
            </a:extLst>
          </p:cNvPr>
          <p:cNvSpPr txBox="1"/>
          <p:nvPr/>
        </p:nvSpPr>
        <p:spPr>
          <a:xfrm>
            <a:off x="8685888" y="58723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E8F3FF7-D670-4CB1-9F0E-D00E72A6B8D0}"/>
              </a:ext>
            </a:extLst>
          </p:cNvPr>
          <p:cNvSpPr txBox="1"/>
          <p:nvPr/>
        </p:nvSpPr>
        <p:spPr>
          <a:xfrm>
            <a:off x="159868" y="296673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8F3FF7-D670-4CB1-9F0E-D00E72A6B8D0}"/>
              </a:ext>
            </a:extLst>
          </p:cNvPr>
          <p:cNvSpPr txBox="1"/>
          <p:nvPr/>
        </p:nvSpPr>
        <p:spPr>
          <a:xfrm>
            <a:off x="6230591" y="296673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5612454"/>
              </p:ext>
            </p:extLst>
          </p:nvPr>
        </p:nvGraphicFramePr>
        <p:xfrm>
          <a:off x="391684" y="3629816"/>
          <a:ext cx="2593133" cy="24377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8" r:id="rId17" imgW="3576508" imgH="3362480" progId="Prism8.Document">
                  <p:embed/>
                </p:oleObj>
              </mc:Choice>
              <mc:Fallback>
                <p:oleObj name="Prism 8" r:id="rId17" imgW="3576508" imgH="336248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91684" y="3629816"/>
                        <a:ext cx="2593133" cy="24377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8844071"/>
              </p:ext>
            </p:extLst>
          </p:nvPr>
        </p:nvGraphicFramePr>
        <p:xfrm>
          <a:off x="3225977" y="3579058"/>
          <a:ext cx="2592019" cy="25392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8" r:id="rId19" imgW="3431733" imgH="3362480" progId="Prism8.Document">
                  <p:embed/>
                </p:oleObj>
              </mc:Choice>
              <mc:Fallback>
                <p:oleObj name="Prism 8" r:id="rId19" imgW="3431733" imgH="336248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225977" y="3579058"/>
                        <a:ext cx="2592019" cy="25392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10238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8DF77DE-4B6D-4E7F-91E0-4D76BFAB9E9A}"/>
              </a:ext>
            </a:extLst>
          </p:cNvPr>
          <p:cNvSpPr txBox="1"/>
          <p:nvPr/>
        </p:nvSpPr>
        <p:spPr>
          <a:xfrm>
            <a:off x="339364" y="870045"/>
            <a:ext cx="302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7E5C210-784A-4AED-8C88-3B669B1DABD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2330" y="848332"/>
          <a:ext cx="4442135" cy="3007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7" r:id="rId3" imgW="4689687" imgH="3174398" progId="Prism7.Document">
                  <p:embed/>
                </p:oleObj>
              </mc:Choice>
              <mc:Fallback>
                <p:oleObj name="Prism 7" r:id="rId3" imgW="4689687" imgH="3174398" progId="Prism7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7E5C210-784A-4AED-8C88-3B669B1DAB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2330" y="848332"/>
                        <a:ext cx="4442135" cy="3007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A354645D-2047-407E-9CB0-1708C9DF1E88}"/>
              </a:ext>
            </a:extLst>
          </p:cNvPr>
          <p:cNvSpPr txBox="1"/>
          <p:nvPr/>
        </p:nvSpPr>
        <p:spPr>
          <a:xfrm>
            <a:off x="5588601" y="80807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FB760DF9-EF36-4E44-87A2-81365DF3436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2330" y="3742360"/>
          <a:ext cx="4833128" cy="3007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7" r:id="rId5" imgW="5105644" imgH="3174398" progId="Prism7.Document">
                  <p:embed/>
                </p:oleObj>
              </mc:Choice>
              <mc:Fallback>
                <p:oleObj name="Prism 7" r:id="rId5" imgW="5105644" imgH="3174398" progId="Prism7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B760DF9-EF36-4E44-87A2-81365DF343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2330" y="3742360"/>
                        <a:ext cx="4833128" cy="3007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itle 1">
            <a:extLst>
              <a:ext uri="{FF2B5EF4-FFF2-40B4-BE49-F238E27FC236}">
                <a16:creationId xmlns:a16="http://schemas.microsoft.com/office/drawing/2014/main" id="{CCE970E9-81A1-4A7A-B653-E6CF20ABE14A}"/>
              </a:ext>
            </a:extLst>
          </p:cNvPr>
          <p:cNvSpPr txBox="1">
            <a:spLocks/>
          </p:cNvSpPr>
          <p:nvPr/>
        </p:nvSpPr>
        <p:spPr>
          <a:xfrm>
            <a:off x="225856" y="248147"/>
            <a:ext cx="11040000" cy="369333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Immune checkpoint blockade increases immune-mediated tumour death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B30D5BE8-E22A-42FE-9039-F0B5E1691A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343650" y="847725"/>
          <a:ext cx="3775075" cy="278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7" r:id="rId7" imgW="4181896" imgH="3082919" progId="Prism7.Document">
                  <p:embed/>
                </p:oleObj>
              </mc:Choice>
              <mc:Fallback>
                <p:oleObj name="Prism 7" r:id="rId7" imgW="4181896" imgH="3082919" progId="Prism7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B30D5BE8-E22A-42FE-9039-F0B5E1691A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43650" y="847725"/>
                        <a:ext cx="3775075" cy="2782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6491C2D7-D2EE-4868-9789-32AD7C06016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57950" y="3927475"/>
          <a:ext cx="3689350" cy="271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ism 7" r:id="rId9" imgW="4181896" imgH="3082919" progId="Prism7.Document">
                  <p:embed/>
                </p:oleObj>
              </mc:Choice>
              <mc:Fallback>
                <p:oleObj name="Prism 7" r:id="rId9" imgW="4181896" imgH="3082919" progId="Prism7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6491C2D7-D2EE-4868-9789-32AD7C0601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457950" y="3927475"/>
                        <a:ext cx="3689350" cy="2717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599506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1FB77D0C-F10F-4940-98D6-A1E8298A1EC8}"/>
              </a:ext>
            </a:extLst>
          </p:cNvPr>
          <p:cNvGrpSpPr/>
          <p:nvPr/>
        </p:nvGrpSpPr>
        <p:grpSpPr>
          <a:xfrm>
            <a:off x="1989490" y="454240"/>
            <a:ext cx="9143574" cy="2384393"/>
            <a:chOff x="2177408" y="254629"/>
            <a:chExt cx="9143574" cy="238439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D11DDD2-9A92-459D-B2FC-E4276935E4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4274" y="618783"/>
              <a:ext cx="1748553" cy="170497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9A201C0-F011-4FD5-80B2-705DFCFE37AB}"/>
                </a:ext>
              </a:extLst>
            </p:cNvPr>
            <p:cNvSpPr txBox="1"/>
            <p:nvPr/>
          </p:nvSpPr>
          <p:spPr>
            <a:xfrm>
              <a:off x="2870958" y="328183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SC270319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858D310-5D15-46C3-8480-F3066C925C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572429" y="572557"/>
              <a:ext cx="1748553" cy="170497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BD0E618-ECB0-4362-A43A-18E40DC899A1}"/>
                </a:ext>
              </a:extLst>
            </p:cNvPr>
            <p:cNvSpPr txBox="1"/>
            <p:nvPr/>
          </p:nvSpPr>
          <p:spPr>
            <a:xfrm>
              <a:off x="9991750" y="254629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SC130519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4A406A4-237E-47E8-A519-1352A9E567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208184" y="586683"/>
              <a:ext cx="1856085" cy="180982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770BE0B-24D0-4C31-A562-FBAA8637786E}"/>
                </a:ext>
              </a:extLst>
            </p:cNvPr>
            <p:cNvSpPr txBox="1"/>
            <p:nvPr/>
          </p:nvSpPr>
          <p:spPr>
            <a:xfrm>
              <a:off x="6732071" y="307077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SC230519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60374F3-6ADE-405B-ADFA-AFFC5CE3E49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10162" y="586683"/>
              <a:ext cx="1879096" cy="1787711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0E40A39-799F-4C05-B9FA-4426A5F79E38}"/>
                </a:ext>
              </a:extLst>
            </p:cNvPr>
            <p:cNvSpPr txBox="1"/>
            <p:nvPr/>
          </p:nvSpPr>
          <p:spPr>
            <a:xfrm>
              <a:off x="4913301" y="321720"/>
              <a:ext cx="11512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SC02051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8080BD2-1DFC-4C03-8742-F930DC80811F}"/>
                </a:ext>
              </a:extLst>
            </p:cNvPr>
            <p:cNvSpPr txBox="1"/>
            <p:nvPr/>
          </p:nvSpPr>
          <p:spPr>
            <a:xfrm rot="16200000">
              <a:off x="1974788" y="1216774"/>
              <a:ext cx="77457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CD14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A8043A6-0C86-4516-85DA-B0C867826B9B}"/>
                </a:ext>
              </a:extLst>
            </p:cNvPr>
            <p:cNvSpPr/>
            <p:nvPr/>
          </p:nvSpPr>
          <p:spPr>
            <a:xfrm>
              <a:off x="3133127" y="2264187"/>
              <a:ext cx="6437593" cy="1232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5CC6FB0-C445-48B7-B716-5E33CCD1B74D}"/>
                </a:ext>
              </a:extLst>
            </p:cNvPr>
            <p:cNvSpPr txBox="1"/>
            <p:nvPr/>
          </p:nvSpPr>
          <p:spPr>
            <a:xfrm>
              <a:off x="2317802" y="2269690"/>
              <a:ext cx="77457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CD68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A8BBD704-D8D7-4168-B3F3-7225A9369B76}"/>
                </a:ext>
              </a:extLst>
            </p:cNvPr>
            <p:cNvCxnSpPr/>
            <p:nvPr/>
          </p:nvCxnSpPr>
          <p:spPr>
            <a:xfrm>
              <a:off x="3133127" y="2471762"/>
              <a:ext cx="466161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FBD8753D-FF49-418F-8DCC-8B0C1D66556B}"/>
              </a:ext>
            </a:extLst>
          </p:cNvPr>
          <p:cNvSpPr txBox="1"/>
          <p:nvPr/>
        </p:nvSpPr>
        <p:spPr>
          <a:xfrm>
            <a:off x="-9456" y="1447162"/>
            <a:ext cx="21836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Monocytes/Macrophages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5.31±2.36%)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91E34C0-C54D-40CA-ADC6-2A2973B77D84}"/>
              </a:ext>
            </a:extLst>
          </p:cNvPr>
          <p:cNvGrpSpPr/>
          <p:nvPr/>
        </p:nvGrpSpPr>
        <p:grpSpPr>
          <a:xfrm>
            <a:off x="973867" y="2848571"/>
            <a:ext cx="10180985" cy="2025384"/>
            <a:chOff x="2860195" y="3118885"/>
            <a:chExt cx="10180985" cy="2025384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27324CE-9B6F-4AE6-B877-A48C68C1A37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249050" y="3160167"/>
              <a:ext cx="1792130" cy="1704975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D0032A2E-DF5A-49D4-9932-7D19C6322F3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906594" y="3118885"/>
              <a:ext cx="1844615" cy="1754907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85BFB08-A04B-4219-832A-4252BC24D45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014346" y="3143384"/>
              <a:ext cx="1850971" cy="1760954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7EF1379-5070-4B10-9A5D-90D053BA9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58517" y="3179722"/>
              <a:ext cx="1803824" cy="1716100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6586842-5FC3-4674-B357-54D32D162841}"/>
                </a:ext>
              </a:extLst>
            </p:cNvPr>
            <p:cNvSpPr/>
            <p:nvPr/>
          </p:nvSpPr>
          <p:spPr>
            <a:xfrm>
              <a:off x="2860195" y="4818533"/>
              <a:ext cx="6437593" cy="1232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AC5003A-AA7D-4B03-BBFC-8874A1BD2B0B}"/>
                </a:ext>
              </a:extLst>
            </p:cNvPr>
            <p:cNvSpPr txBox="1"/>
            <p:nvPr/>
          </p:nvSpPr>
          <p:spPr>
            <a:xfrm>
              <a:off x="3828839" y="4774937"/>
              <a:ext cx="97975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err="1">
                  <a:latin typeface="Arial" panose="020B0604020202020204" pitchFamily="34" charset="0"/>
                  <a:cs typeface="Arial" panose="020B0604020202020204" pitchFamily="34" charset="0"/>
                </a:rPr>
                <a:t>EpCAM</a:t>
              </a:r>
              <a:endParaRPr lang="en-GB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90671234-CE17-4499-AFE9-17FA67BE782A}"/>
                </a:ext>
              </a:extLst>
            </p:cNvPr>
            <p:cNvCxnSpPr/>
            <p:nvPr/>
          </p:nvCxnSpPr>
          <p:spPr>
            <a:xfrm>
              <a:off x="4888238" y="5003199"/>
              <a:ext cx="466161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9" name="Title 1">
            <a:extLst>
              <a:ext uri="{FF2B5EF4-FFF2-40B4-BE49-F238E27FC236}">
                <a16:creationId xmlns:a16="http://schemas.microsoft.com/office/drawing/2014/main" id="{1F7B81BC-DDEF-48C1-B7D1-BF28CD0FF25B}"/>
              </a:ext>
            </a:extLst>
          </p:cNvPr>
          <p:cNvSpPr txBox="1">
            <a:spLocks/>
          </p:cNvSpPr>
          <p:nvPr/>
        </p:nvSpPr>
        <p:spPr>
          <a:xfrm>
            <a:off x="93064" y="50503"/>
            <a:ext cx="11040000" cy="369333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Cell characterisation of primary ovarian cancer ascites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7E2ABFD3-C111-4427-AE07-DC246465769F}"/>
              </a:ext>
            </a:extLst>
          </p:cNvPr>
          <p:cNvGrpSpPr/>
          <p:nvPr/>
        </p:nvGrpSpPr>
        <p:grpSpPr>
          <a:xfrm>
            <a:off x="973867" y="4827733"/>
            <a:ext cx="10157488" cy="2030267"/>
            <a:chOff x="2933295" y="4769342"/>
            <a:chExt cx="10157488" cy="2030267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9A9465A-C80C-4006-974C-D95C37AD7B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342230" y="4837623"/>
              <a:ext cx="1748553" cy="1704975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CBFE69A1-2274-48AE-8FDE-AE07ECD130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027726" y="4769342"/>
              <a:ext cx="1790812" cy="174618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5A59AB9B-2055-4460-962D-DED57CE464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109937" y="4803902"/>
              <a:ext cx="1754178" cy="171046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B387DAC0-FAE6-41F0-8395-C93EEF5759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b="18174"/>
            <a:stretch/>
          </p:blipFill>
          <p:spPr>
            <a:xfrm>
              <a:off x="4166514" y="4803902"/>
              <a:ext cx="2308866" cy="1839303"/>
            </a:xfrm>
            <a:prstGeom prst="rect">
              <a:avLst/>
            </a:prstGeom>
          </p:spPr>
        </p:pic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718E44DB-ED17-42A7-8238-E352D5B3D8B8}"/>
                </a:ext>
              </a:extLst>
            </p:cNvPr>
            <p:cNvSpPr/>
            <p:nvPr/>
          </p:nvSpPr>
          <p:spPr>
            <a:xfrm>
              <a:off x="2933295" y="6480961"/>
              <a:ext cx="6437593" cy="1232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B017068-5A6A-45F0-97D6-3055DA958401}"/>
                </a:ext>
              </a:extLst>
            </p:cNvPr>
            <p:cNvSpPr txBox="1"/>
            <p:nvPr/>
          </p:nvSpPr>
          <p:spPr>
            <a:xfrm>
              <a:off x="3993545" y="6430277"/>
              <a:ext cx="67197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WT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6D3D8CB-7368-4AEC-80F7-89D611D7AAA0}"/>
                </a:ext>
              </a:extLst>
            </p:cNvPr>
            <p:cNvSpPr txBox="1"/>
            <p:nvPr/>
          </p:nvSpPr>
          <p:spPr>
            <a:xfrm rot="16200000">
              <a:off x="3610849" y="5464992"/>
              <a:ext cx="96693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CA-125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7D2A241C-0664-4CDA-8AD6-EEB2FD83C95A}"/>
                </a:ext>
              </a:extLst>
            </p:cNvPr>
            <p:cNvCxnSpPr/>
            <p:nvPr/>
          </p:nvCxnSpPr>
          <p:spPr>
            <a:xfrm>
              <a:off x="4993239" y="6643205"/>
              <a:ext cx="466161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0E3D95E0-CD3E-4EF0-987C-E734F83178B2}"/>
              </a:ext>
            </a:extLst>
          </p:cNvPr>
          <p:cNvSpPr txBox="1"/>
          <p:nvPr/>
        </p:nvSpPr>
        <p:spPr>
          <a:xfrm>
            <a:off x="10081598" y="2354020"/>
            <a:ext cx="77457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4E5A46B-8DEE-4F55-94F1-B2C2FC447034}"/>
              </a:ext>
            </a:extLst>
          </p:cNvPr>
          <p:cNvSpPr txBox="1"/>
          <p:nvPr/>
        </p:nvSpPr>
        <p:spPr>
          <a:xfrm rot="16200000">
            <a:off x="8975437" y="1394894"/>
            <a:ext cx="77457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91B9129-0E77-47DC-B478-8BE6868B9893}"/>
              </a:ext>
            </a:extLst>
          </p:cNvPr>
          <p:cNvSpPr txBox="1"/>
          <p:nvPr/>
        </p:nvSpPr>
        <p:spPr>
          <a:xfrm>
            <a:off x="9975354" y="4506284"/>
            <a:ext cx="97975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EpCAM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6405F0-9D52-46D6-89FE-724FFAE97ABE}"/>
              </a:ext>
            </a:extLst>
          </p:cNvPr>
          <p:cNvSpPr txBox="1"/>
          <p:nvPr/>
        </p:nvSpPr>
        <p:spPr>
          <a:xfrm>
            <a:off x="10129241" y="6493479"/>
            <a:ext cx="67197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WT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86A2A35-4E8A-4FA6-8F89-223655EEFE4C}"/>
              </a:ext>
            </a:extLst>
          </p:cNvPr>
          <p:cNvSpPr txBox="1"/>
          <p:nvPr/>
        </p:nvSpPr>
        <p:spPr>
          <a:xfrm rot="16200000">
            <a:off x="8879257" y="5523384"/>
            <a:ext cx="9669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-12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46FCA23-2BFB-4233-9657-7DFE1B7B2325}"/>
              </a:ext>
            </a:extLst>
          </p:cNvPr>
          <p:cNvSpPr txBox="1"/>
          <p:nvPr/>
        </p:nvSpPr>
        <p:spPr>
          <a:xfrm>
            <a:off x="23475" y="3496434"/>
            <a:ext cx="18069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Ovarian cancer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F3D0B8A-C539-4727-B1E1-EA82ED0A8FD5}"/>
              </a:ext>
            </a:extLst>
          </p:cNvPr>
          <p:cNvSpPr txBox="1"/>
          <p:nvPr/>
        </p:nvSpPr>
        <p:spPr>
          <a:xfrm>
            <a:off x="23475" y="5518180"/>
            <a:ext cx="18069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Ovarian cancer cells</a:t>
            </a:r>
          </a:p>
        </p:txBody>
      </p:sp>
    </p:spTree>
    <p:extLst>
      <p:ext uri="{BB962C8B-B14F-4D97-AF65-F5344CB8AC3E}">
        <p14:creationId xmlns:p14="http://schemas.microsoft.com/office/powerpoint/2010/main" val="4263376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7</Words>
  <Application>Microsoft Office PowerPoint</Application>
  <PresentationFormat>Widescreen</PresentationFormat>
  <Paragraphs>3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4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7</vt:lpstr>
      <vt:lpstr>Prism 6</vt:lpstr>
      <vt:lpstr>Prism 8</vt:lpstr>
      <vt:lpstr>GraphPad Prism 8 Project</vt:lpstr>
      <vt:lpstr>Figure S1. Assay setup and gating strategy</vt:lpstr>
      <vt:lpstr>Figure S2. Characterisation of the TICS</vt:lpstr>
      <vt:lpstr>PowerPoint Presentation</vt:lpstr>
      <vt:lpstr>PowerPoint Presentation</vt:lpstr>
    </vt:vector>
  </TitlesOfParts>
  <Company>Uppsala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Assay setup and gating strategy</dc:title>
  <dc:creator>Yumeng Mao</dc:creator>
  <cp:lastModifiedBy>Yumeng Mao</cp:lastModifiedBy>
  <cp:revision>3</cp:revision>
  <dcterms:created xsi:type="dcterms:W3CDTF">2019-12-10T11:25:30Z</dcterms:created>
  <dcterms:modified xsi:type="dcterms:W3CDTF">2020-02-06T12:06:59Z</dcterms:modified>
</cp:coreProperties>
</file>